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uslan Al-Ali" userId="5173ad95-b372-4229-9a5a-2520dfe91a1e" providerId="ADAL" clId="{0977E656-3A4F-4694-B703-10047861C922}"/>
    <pc:docChg chg="delSld modSld">
      <pc:chgData name="Ruslan Al-Ali" userId="5173ad95-b372-4229-9a5a-2520dfe91a1e" providerId="ADAL" clId="{0977E656-3A4F-4694-B703-10047861C922}" dt="2023-11-09T23:35:55.971" v="2" actId="20577"/>
      <pc:docMkLst>
        <pc:docMk/>
      </pc:docMkLst>
      <pc:sldChg chg="del">
        <pc:chgData name="Ruslan Al-Ali" userId="5173ad95-b372-4229-9a5a-2520dfe91a1e" providerId="ADAL" clId="{0977E656-3A4F-4694-B703-10047861C922}" dt="2023-11-09T23:34:53.984" v="0" actId="47"/>
        <pc:sldMkLst>
          <pc:docMk/>
          <pc:sldMk cId="1690563309" sldId="256"/>
        </pc:sldMkLst>
      </pc:sldChg>
      <pc:sldChg chg="modSp mod">
        <pc:chgData name="Ruslan Al-Ali" userId="5173ad95-b372-4229-9a5a-2520dfe91a1e" providerId="ADAL" clId="{0977E656-3A4F-4694-B703-10047861C922}" dt="2023-11-09T23:35:55.971" v="2" actId="20577"/>
        <pc:sldMkLst>
          <pc:docMk/>
          <pc:sldMk cId="1429023585" sldId="261"/>
        </pc:sldMkLst>
        <pc:spChg chg="mod">
          <ac:chgData name="Ruslan Al-Ali" userId="5173ad95-b372-4229-9a5a-2520dfe91a1e" providerId="ADAL" clId="{0977E656-3A4F-4694-B703-10047861C922}" dt="2023-11-09T23:35:55.971" v="2" actId="20577"/>
          <ac:spMkLst>
            <pc:docMk/>
            <pc:sldMk cId="1429023585" sldId="261"/>
            <ac:spMk id="4" creationId="{D92B9BC1-B239-D113-2AD5-A2E482A27282}"/>
          </ac:spMkLst>
        </pc:spChg>
      </pc:sldChg>
      <pc:sldChg chg="modSp mod">
        <pc:chgData name="Ruslan Al-Ali" userId="5173ad95-b372-4229-9a5a-2520dfe91a1e" providerId="ADAL" clId="{0977E656-3A4F-4694-B703-10047861C922}" dt="2023-11-09T23:35:51.288" v="1" actId="20577"/>
        <pc:sldMkLst>
          <pc:docMk/>
          <pc:sldMk cId="3639374541" sldId="265"/>
        </pc:sldMkLst>
        <pc:spChg chg="mod">
          <ac:chgData name="Ruslan Al-Ali" userId="5173ad95-b372-4229-9a5a-2520dfe91a1e" providerId="ADAL" clId="{0977E656-3A4F-4694-B703-10047861C922}" dt="2023-11-09T23:35:51.288" v="1" actId="20577"/>
          <ac:spMkLst>
            <pc:docMk/>
            <pc:sldMk cId="3639374541" sldId="265"/>
            <ac:spMk id="9" creationId="{29324915-2A9C-F6E4-812C-84C4A7C67C8E}"/>
          </ac:spMkLst>
        </pc:spChg>
      </pc:sldChg>
      <pc:sldChg chg="del">
        <pc:chgData name="Ruslan Al-Ali" userId="5173ad95-b372-4229-9a5a-2520dfe91a1e" providerId="ADAL" clId="{0977E656-3A4F-4694-B703-10047861C922}" dt="2023-11-09T23:34:53.984" v="0" actId="47"/>
        <pc:sldMkLst>
          <pc:docMk/>
          <pc:sldMk cId="3603088625" sldId="267"/>
        </pc:sldMkLst>
      </pc:sldChg>
      <pc:sldChg chg="del">
        <pc:chgData name="Ruslan Al-Ali" userId="5173ad95-b372-4229-9a5a-2520dfe91a1e" providerId="ADAL" clId="{0977E656-3A4F-4694-B703-10047861C922}" dt="2023-11-09T23:34:53.984" v="0" actId="47"/>
        <pc:sldMkLst>
          <pc:docMk/>
          <pc:sldMk cId="2059149402" sldId="273"/>
        </pc:sldMkLst>
      </pc:sldChg>
      <pc:sldChg chg="del">
        <pc:chgData name="Ruslan Al-Ali" userId="5173ad95-b372-4229-9a5a-2520dfe91a1e" providerId="ADAL" clId="{0977E656-3A4F-4694-B703-10047861C922}" dt="2023-11-09T23:34:53.984" v="0" actId="47"/>
        <pc:sldMkLst>
          <pc:docMk/>
          <pc:sldMk cId="697608819" sldId="275"/>
        </pc:sldMkLst>
      </pc:sldChg>
      <pc:sldChg chg="del">
        <pc:chgData name="Ruslan Al-Ali" userId="5173ad95-b372-4229-9a5a-2520dfe91a1e" providerId="ADAL" clId="{0977E656-3A4F-4694-B703-10047861C922}" dt="2023-11-09T23:34:53.984" v="0" actId="47"/>
        <pc:sldMkLst>
          <pc:docMk/>
          <pc:sldMk cId="771822717" sldId="27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E9D28C-DC03-4E60-B6B6-12268C9430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68DC81-EC45-66FA-5A65-03D2D52C72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A3259-78AC-7095-8E4B-3BAAC1C22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61B11-6154-D989-E0A0-9D29638DD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B7031-F3BA-AABA-C842-FBDBC96A6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561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B9F03-2810-1472-ABB9-09C68E92E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C21BF2-7F25-6A01-D46E-AC18649CF1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380916-5B48-7EBC-F588-322EA05A3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303285-18DF-7EA1-72FB-2173E7E81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1DF1C-B31B-B804-618D-DB2453FD7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240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27E7A2-0455-6BDE-05EA-12BFDD88D3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0AC736-6BEC-F0F8-39C5-C4A4E43D83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8DAF7D-C670-3215-52C0-580BAF8B9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C9A1F6-C9F8-9308-EE5A-F079F0478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44A656-FCAB-AD83-0CA8-444BE6F89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801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251DBE-1E81-0190-BB3C-639312CAF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231F30-82FB-3207-212B-84A1139060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41B9CA-C7E5-4D82-6CB7-C11F63230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22C01-A26A-81B3-3303-5D02BAEC8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BAF43E-7CBA-906B-29A1-01D5795E1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539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206CC-E717-CABE-E8C2-9DE2D0F1D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D125C9-5AA8-A502-4C37-4C97EC8C80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3ADD47-F598-595F-3B8C-08EDAA5FA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BE6C3-09DA-E64D-EFA9-3DE2655DD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0B34B-E677-F24C-9F81-5CE58D19A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674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71361-0875-D280-B824-717EA9A49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EA0A09-8D78-4FC1-689C-D28811B588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A06994-B354-70BC-3D93-AE6BA637CA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DA2BC6-3815-29FD-9853-73B1DAB10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607CB5-FD6B-212C-90DF-9383CB15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6C9CB-D2D1-C28B-4B7E-40886CAA0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750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08BF7-B51A-0493-3F04-715F94272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5A021A-9CD2-5C13-5D59-9E5E7D855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B3E780-F3D2-9A8B-2F43-0DA97B39FC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56FA42-17E0-A5DD-A3AB-33A2A67471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F61848-6C05-5F58-B20D-F056380172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831D6C-9F46-3F1E-3305-6CE0C1AE0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B3BDAE-F4EF-4A1A-623B-3312DB686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21994C-9CC7-F99C-A435-383153854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633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A1EE50-CFBA-07E0-90EB-FD5C1C468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65F3BD-F0F4-7202-2765-80D70398F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90157B-9F38-4EE2-2856-BF57E939C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42831C-CC30-3C45-1017-F99597EDA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29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3911A6-2866-4438-D0B1-33BB03CBF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C85341-03AA-902C-3287-4EDC3648C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392C2B-A737-4259-77B0-04DBBFCF3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195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0E5679-D6BD-6205-E764-416769A1A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26A63B-557B-F71F-E5A1-F1230E4C24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68D759-626A-F5F6-23DD-2A1C64A0E2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1D00C3-6FCE-A780-09FF-699531FD0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F9CA28-43A8-7523-CD5E-7D9A14AC8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12EFE4-42CF-F75A-0886-C4A120EA5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13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76B273-129E-BF7E-B4BC-CC03AB8D9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C56A69-8AB8-785A-D00E-3A349B7E9C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6A7EF-39D8-8A5F-4F83-ACF62121BA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970AE-3279-23FF-9A59-AD9EE96EC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B945DD-0566-DA25-8E4D-D04840698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453E71-C163-1508-3DDC-0EB654DCA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176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DFA33B-E256-95E4-E4F7-B2B425415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C0CBE3-783C-F2F3-9EB4-C3B1A49426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8EF8BE-C90D-8A73-14A0-B8A4F68627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9E101-6AF6-4948-8A26-6AA0614DAF4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5DA261-4302-4A55-B880-8C6BBAA211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8B444-E1BF-7886-A53C-7268C97372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C8406-A8ED-4745-92EB-67DC40F64F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896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1BC5F8FE-85C7-0109-87F2-EF4426E265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9888" y="3165275"/>
            <a:ext cx="2552270" cy="250692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36B35E8-8DAB-9BF0-8B87-A9067D9FA3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9887" y="239654"/>
            <a:ext cx="2552271" cy="250692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885D514-A807-684B-38B5-78C1A07C51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56694" y="268356"/>
            <a:ext cx="2176126" cy="25681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D8DC10B-AC7D-7217-0BDD-5A92816B5E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56694" y="3165275"/>
            <a:ext cx="2215204" cy="243064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9324915-2A9C-F6E4-812C-84C4A7C67C8E}"/>
              </a:ext>
            </a:extLst>
          </p:cNvPr>
          <p:cNvSpPr txBox="1"/>
          <p:nvPr/>
        </p:nvSpPr>
        <p:spPr>
          <a:xfrm>
            <a:off x="909449" y="5725820"/>
            <a:ext cx="6383326" cy="1004186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)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colon cancer stages negatively with age of participation (onset).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o correlation in pancreatic cancer between Age of participation and stage of cancer.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vival does not correlate with detection of ctDNA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colon cancer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tDNA detection correlates with stage of colon cancer (p-value &lt;0.01)</a:t>
            </a:r>
            <a:endParaRPr lang="en-US" sz="14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2A1F1A3-DE5F-8F60-35A0-4C0CAA33B825}"/>
              </a:ext>
            </a:extLst>
          </p:cNvPr>
          <p:cNvSpPr txBox="1"/>
          <p:nvPr/>
        </p:nvSpPr>
        <p:spPr>
          <a:xfrm>
            <a:off x="909449" y="54988"/>
            <a:ext cx="400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7864A7-1A11-8C8A-F6A5-35F5B86EA51A}"/>
              </a:ext>
            </a:extLst>
          </p:cNvPr>
          <p:cNvSpPr txBox="1"/>
          <p:nvPr/>
        </p:nvSpPr>
        <p:spPr>
          <a:xfrm>
            <a:off x="949237" y="2908521"/>
            <a:ext cx="400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927A960-ACC8-BE06-13CA-C25B31050F89}"/>
              </a:ext>
            </a:extLst>
          </p:cNvPr>
          <p:cNvSpPr txBox="1"/>
          <p:nvPr/>
        </p:nvSpPr>
        <p:spPr>
          <a:xfrm>
            <a:off x="4113647" y="39533"/>
            <a:ext cx="400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DE9E85-A5BE-16DF-CF89-0F1CCEA99855}"/>
              </a:ext>
            </a:extLst>
          </p:cNvPr>
          <p:cNvSpPr txBox="1"/>
          <p:nvPr/>
        </p:nvSpPr>
        <p:spPr>
          <a:xfrm>
            <a:off x="1844579" y="0"/>
            <a:ext cx="13620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>
                <a:solidFill>
                  <a:schemeClr val="bg1">
                    <a:lumMod val="50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n cancer </a:t>
            </a:r>
            <a:endParaRPr lang="en-US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E67307C-BA75-C8D5-9B72-8991BFD56B72}"/>
              </a:ext>
            </a:extLst>
          </p:cNvPr>
          <p:cNvSpPr txBox="1"/>
          <p:nvPr/>
        </p:nvSpPr>
        <p:spPr>
          <a:xfrm>
            <a:off x="1603973" y="2872287"/>
            <a:ext cx="18640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>
                <a:solidFill>
                  <a:schemeClr val="bg1">
                    <a:lumMod val="50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ncreatic cancer </a:t>
            </a:r>
            <a:endParaRPr lang="en-US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3CCE7E8-01B1-D54B-2EBD-F4B43539DAC5}"/>
              </a:ext>
            </a:extLst>
          </p:cNvPr>
          <p:cNvSpPr txBox="1"/>
          <p:nvPr/>
        </p:nvSpPr>
        <p:spPr>
          <a:xfrm>
            <a:off x="4741238" y="-24405"/>
            <a:ext cx="13620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>
                <a:solidFill>
                  <a:schemeClr val="bg1">
                    <a:lumMod val="50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n cancer </a:t>
            </a:r>
            <a:endParaRPr lang="en-US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2391961-FF62-8090-DAEB-E6C603EF4DAA}"/>
              </a:ext>
            </a:extLst>
          </p:cNvPr>
          <p:cNvSpPr txBox="1"/>
          <p:nvPr/>
        </p:nvSpPr>
        <p:spPr>
          <a:xfrm>
            <a:off x="4741238" y="2831389"/>
            <a:ext cx="13620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>
                <a:solidFill>
                  <a:schemeClr val="bg1">
                    <a:lumMod val="50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n cancer </a:t>
            </a:r>
            <a:endParaRPr lang="en-US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EF72E62-76A1-BE60-A351-8963E9471B9F}"/>
              </a:ext>
            </a:extLst>
          </p:cNvPr>
          <p:cNvSpPr txBox="1"/>
          <p:nvPr/>
        </p:nvSpPr>
        <p:spPr>
          <a:xfrm>
            <a:off x="4110244" y="2926907"/>
            <a:ext cx="400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3639374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2B9BC1-B239-D113-2AD5-A2E482A27282}"/>
              </a:ext>
            </a:extLst>
          </p:cNvPr>
          <p:cNvSpPr txBox="1"/>
          <p:nvPr/>
        </p:nvSpPr>
        <p:spPr>
          <a:xfrm>
            <a:off x="662358" y="4838597"/>
            <a:ext cx="9657299" cy="773673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)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th of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quencing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verage for each region before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plicon-quantity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ptimization (log). One region in KRAS failed to amplify due to low complexity of the sequence. The region removed from the pools. 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verage of different regions is comparable after optimization (log). </a:t>
            </a:r>
            <a:endParaRPr lang="en-US" sz="14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3A087F3E-B7D4-AAD9-2382-64EE89D0B9DD}"/>
              </a:ext>
            </a:extLst>
          </p:cNvPr>
          <p:cNvGrpSpPr/>
          <p:nvPr/>
        </p:nvGrpSpPr>
        <p:grpSpPr>
          <a:xfrm>
            <a:off x="662358" y="1930313"/>
            <a:ext cx="7362549" cy="2877327"/>
            <a:chOff x="662358" y="1930313"/>
            <a:chExt cx="7362549" cy="287732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912145D-2A24-403C-B00E-01B70CDD0E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78701" y="2038455"/>
              <a:ext cx="3646206" cy="275728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98522E2-70AC-4472-9F4F-52BE3B4FED4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51717" y="2050359"/>
              <a:ext cx="3626984" cy="2757281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8E30D74-D08A-4B93-9256-A064F45F9486}"/>
                </a:ext>
              </a:extLst>
            </p:cNvPr>
            <p:cNvSpPr txBox="1"/>
            <p:nvPr/>
          </p:nvSpPr>
          <p:spPr>
            <a:xfrm>
              <a:off x="4822329" y="2114979"/>
              <a:ext cx="30828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/>
                <a:t>Depth of coverage after optimizatio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A433E17-6B98-416A-8C0E-52F13A15F4C7}"/>
                </a:ext>
              </a:extLst>
            </p:cNvPr>
            <p:cNvSpPr txBox="1"/>
            <p:nvPr/>
          </p:nvSpPr>
          <p:spPr>
            <a:xfrm>
              <a:off x="1214531" y="2061054"/>
              <a:ext cx="30828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/>
                <a:t>Initial depth of coverage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35C4EA5-E8A2-5708-E9EC-C60088F6F2EB}"/>
                </a:ext>
              </a:extLst>
            </p:cNvPr>
            <p:cNvSpPr txBox="1"/>
            <p:nvPr/>
          </p:nvSpPr>
          <p:spPr>
            <a:xfrm>
              <a:off x="662358" y="1930313"/>
              <a:ext cx="400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A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4FD4468-367D-A2E7-44EE-8A0FFE7C3FB3}"/>
                </a:ext>
              </a:extLst>
            </p:cNvPr>
            <p:cNvSpPr txBox="1"/>
            <p:nvPr/>
          </p:nvSpPr>
          <p:spPr>
            <a:xfrm>
              <a:off x="4384019" y="1930313"/>
              <a:ext cx="400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B)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6ED3A82-D325-71D7-8BBB-978667645DC4}"/>
                </a:ext>
              </a:extLst>
            </p:cNvPr>
            <p:cNvSpPr/>
            <p:nvPr/>
          </p:nvSpPr>
          <p:spPr>
            <a:xfrm>
              <a:off x="1102517" y="3024187"/>
              <a:ext cx="82296" cy="115252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4D797E4-AFD8-FDBE-4BAF-5293E38A67A0}"/>
                </a:ext>
              </a:extLst>
            </p:cNvPr>
            <p:cNvSpPr/>
            <p:nvPr/>
          </p:nvSpPr>
          <p:spPr>
            <a:xfrm>
              <a:off x="1225689" y="2517775"/>
              <a:ext cx="82296" cy="165893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7C7D33CE-93FB-F443-D060-99F737BA0E53}"/>
                </a:ext>
              </a:extLst>
            </p:cNvPr>
            <p:cNvSpPr/>
            <p:nvPr/>
          </p:nvSpPr>
          <p:spPr>
            <a:xfrm>
              <a:off x="1346478" y="2778124"/>
              <a:ext cx="82296" cy="139858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C236F28-78CB-6D6C-8DDF-C9E9B371962B}"/>
                </a:ext>
              </a:extLst>
            </p:cNvPr>
            <p:cNvSpPr/>
            <p:nvPr/>
          </p:nvSpPr>
          <p:spPr>
            <a:xfrm>
              <a:off x="1467388" y="2889250"/>
              <a:ext cx="82296" cy="128746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BAFFD2F-7CED-C72F-BBE4-AFCB8F6D9E76}"/>
                </a:ext>
              </a:extLst>
            </p:cNvPr>
            <p:cNvSpPr/>
            <p:nvPr/>
          </p:nvSpPr>
          <p:spPr>
            <a:xfrm>
              <a:off x="1587504" y="2775744"/>
              <a:ext cx="82296" cy="140257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58D388E-BE30-5586-2494-4A23F48B8D74}"/>
                </a:ext>
              </a:extLst>
            </p:cNvPr>
            <p:cNvSpPr/>
            <p:nvPr/>
          </p:nvSpPr>
          <p:spPr>
            <a:xfrm>
              <a:off x="1707371" y="2517774"/>
              <a:ext cx="82296" cy="165893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E1E922F-5DAF-00AA-BE99-D902D326952C}"/>
                </a:ext>
              </a:extLst>
            </p:cNvPr>
            <p:cNvSpPr/>
            <p:nvPr/>
          </p:nvSpPr>
          <p:spPr>
            <a:xfrm>
              <a:off x="1829203" y="2517774"/>
              <a:ext cx="82296" cy="165893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28919644-AE7F-6A83-F4E9-27CE25646865}"/>
                </a:ext>
              </a:extLst>
            </p:cNvPr>
            <p:cNvSpPr/>
            <p:nvPr/>
          </p:nvSpPr>
          <p:spPr>
            <a:xfrm>
              <a:off x="1947264" y="2562225"/>
              <a:ext cx="82296" cy="161647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580960EF-E6C6-8657-71F7-FBA1129FFC19}"/>
                </a:ext>
              </a:extLst>
            </p:cNvPr>
            <p:cNvSpPr/>
            <p:nvPr/>
          </p:nvSpPr>
          <p:spPr>
            <a:xfrm>
              <a:off x="2067706" y="3221831"/>
              <a:ext cx="82296" cy="95488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B57CB609-F3E7-A0A9-294F-9513B573BE61}"/>
                </a:ext>
              </a:extLst>
            </p:cNvPr>
            <p:cNvSpPr/>
            <p:nvPr/>
          </p:nvSpPr>
          <p:spPr>
            <a:xfrm>
              <a:off x="2181548" y="2705098"/>
              <a:ext cx="82296" cy="147105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0D5D253-9289-5E17-9D14-6A0AD39908A6}"/>
                </a:ext>
              </a:extLst>
            </p:cNvPr>
            <p:cNvSpPr/>
            <p:nvPr/>
          </p:nvSpPr>
          <p:spPr>
            <a:xfrm>
              <a:off x="2306184" y="2486025"/>
              <a:ext cx="82296" cy="169013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9B0C1DFA-3A01-848F-FE5A-9F485DBB7A25}"/>
                </a:ext>
              </a:extLst>
            </p:cNvPr>
            <p:cNvSpPr/>
            <p:nvPr/>
          </p:nvSpPr>
          <p:spPr>
            <a:xfrm>
              <a:off x="2424669" y="3626644"/>
              <a:ext cx="82296" cy="54951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2773883-FB34-4EDB-5957-B97410018AC7}"/>
                </a:ext>
              </a:extLst>
            </p:cNvPr>
            <p:cNvSpPr/>
            <p:nvPr/>
          </p:nvSpPr>
          <p:spPr>
            <a:xfrm>
              <a:off x="2547970" y="3062288"/>
              <a:ext cx="82296" cy="111386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E8F4F7B-B4C2-E24A-A9A7-8623F091D862}"/>
                </a:ext>
              </a:extLst>
            </p:cNvPr>
            <p:cNvSpPr/>
            <p:nvPr/>
          </p:nvSpPr>
          <p:spPr>
            <a:xfrm>
              <a:off x="2665805" y="2907506"/>
              <a:ext cx="82296" cy="126865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11B6C63C-8858-A367-73B4-335B36913CBE}"/>
                </a:ext>
              </a:extLst>
            </p:cNvPr>
            <p:cNvSpPr/>
            <p:nvPr/>
          </p:nvSpPr>
          <p:spPr>
            <a:xfrm>
              <a:off x="2789935" y="2871786"/>
              <a:ext cx="82296" cy="130437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43FB443-C831-A52C-E725-6AC9CCD83484}"/>
                </a:ext>
              </a:extLst>
            </p:cNvPr>
            <p:cNvSpPr/>
            <p:nvPr/>
          </p:nvSpPr>
          <p:spPr>
            <a:xfrm>
              <a:off x="2906580" y="2865417"/>
              <a:ext cx="82296" cy="131090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EBE44BE-0CF7-D415-9869-CFB8285A39DB}"/>
                </a:ext>
              </a:extLst>
            </p:cNvPr>
            <p:cNvSpPr/>
            <p:nvPr/>
          </p:nvSpPr>
          <p:spPr>
            <a:xfrm>
              <a:off x="3025947" y="2425391"/>
              <a:ext cx="82296" cy="175292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B1891D4C-2467-6A67-409D-A6FCFFBCC410}"/>
                </a:ext>
              </a:extLst>
            </p:cNvPr>
            <p:cNvSpPr/>
            <p:nvPr/>
          </p:nvSpPr>
          <p:spPr>
            <a:xfrm>
              <a:off x="3147712" y="3183731"/>
              <a:ext cx="82296" cy="99242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27E3AE9-630B-6971-E080-54ED179D1CAB}"/>
                </a:ext>
              </a:extLst>
            </p:cNvPr>
            <p:cNvSpPr/>
            <p:nvPr/>
          </p:nvSpPr>
          <p:spPr>
            <a:xfrm>
              <a:off x="3268238" y="2785267"/>
              <a:ext cx="82296" cy="139088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056EA6AB-28E5-B73C-EE89-82CE0F0B94C8}"/>
                </a:ext>
              </a:extLst>
            </p:cNvPr>
            <p:cNvSpPr/>
            <p:nvPr/>
          </p:nvSpPr>
          <p:spPr>
            <a:xfrm>
              <a:off x="3505440" y="2515392"/>
              <a:ext cx="82296" cy="1660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7AC9095B-A518-9017-36BA-AFD067DDEE40}"/>
                </a:ext>
              </a:extLst>
            </p:cNvPr>
            <p:cNvSpPr/>
            <p:nvPr/>
          </p:nvSpPr>
          <p:spPr>
            <a:xfrm>
              <a:off x="3627188" y="2745581"/>
              <a:ext cx="82296" cy="143057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6B8E36D1-2BB2-A0CF-B810-2114B5294CA4}"/>
                </a:ext>
              </a:extLst>
            </p:cNvPr>
            <p:cNvSpPr/>
            <p:nvPr/>
          </p:nvSpPr>
          <p:spPr>
            <a:xfrm>
              <a:off x="3749785" y="2717003"/>
              <a:ext cx="82296" cy="145915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CC49E504-2530-3B41-0C73-C0851DDFACFF}"/>
                </a:ext>
              </a:extLst>
            </p:cNvPr>
            <p:cNvSpPr/>
            <p:nvPr/>
          </p:nvSpPr>
          <p:spPr>
            <a:xfrm>
              <a:off x="3868146" y="2824163"/>
              <a:ext cx="82296" cy="135199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45F2070C-19A8-F476-D4C2-6D752A3A51D4}"/>
                </a:ext>
              </a:extLst>
            </p:cNvPr>
            <p:cNvSpPr/>
            <p:nvPr/>
          </p:nvSpPr>
          <p:spPr>
            <a:xfrm>
              <a:off x="3988261" y="2651602"/>
              <a:ext cx="82296" cy="152455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218182EB-297C-4521-1DA3-631DA4A69E02}"/>
                </a:ext>
              </a:extLst>
            </p:cNvPr>
            <p:cNvSpPr/>
            <p:nvPr/>
          </p:nvSpPr>
          <p:spPr>
            <a:xfrm>
              <a:off x="4109003" y="2500588"/>
              <a:ext cx="82296" cy="167556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2AA60E77-EF7E-A2D4-9A8D-77E4663154E8}"/>
                </a:ext>
              </a:extLst>
            </p:cNvPr>
            <p:cNvSpPr/>
            <p:nvPr/>
          </p:nvSpPr>
          <p:spPr>
            <a:xfrm>
              <a:off x="4229962" y="2656364"/>
              <a:ext cx="82296" cy="151979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BF9E124A-75FB-0917-E00B-11D009C623AE}"/>
                </a:ext>
              </a:extLst>
            </p:cNvPr>
            <p:cNvSpPr/>
            <p:nvPr/>
          </p:nvSpPr>
          <p:spPr>
            <a:xfrm>
              <a:off x="4729501" y="3038753"/>
              <a:ext cx="82296" cy="113740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717B00A-87FB-232E-5BF9-7A0260F96CE1}"/>
                </a:ext>
              </a:extLst>
            </p:cNvPr>
            <p:cNvSpPr/>
            <p:nvPr/>
          </p:nvSpPr>
          <p:spPr>
            <a:xfrm>
              <a:off x="4847154" y="2801763"/>
              <a:ext cx="82296" cy="137439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B5F3547A-9CDD-89C1-5D2F-B40B752F57B1}"/>
                </a:ext>
              </a:extLst>
            </p:cNvPr>
            <p:cNvSpPr/>
            <p:nvPr/>
          </p:nvSpPr>
          <p:spPr>
            <a:xfrm>
              <a:off x="4964807" y="2838435"/>
              <a:ext cx="82296" cy="133772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23AC9329-9872-769B-75C1-2C3200F84D80}"/>
                </a:ext>
              </a:extLst>
            </p:cNvPr>
            <p:cNvSpPr/>
            <p:nvPr/>
          </p:nvSpPr>
          <p:spPr>
            <a:xfrm>
              <a:off x="5087370" y="3101241"/>
              <a:ext cx="82296" cy="107491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2133C83-8F34-2AA5-E054-F7531C3A22EC}"/>
                </a:ext>
              </a:extLst>
            </p:cNvPr>
            <p:cNvSpPr/>
            <p:nvPr/>
          </p:nvSpPr>
          <p:spPr>
            <a:xfrm>
              <a:off x="5207552" y="2918649"/>
              <a:ext cx="82296" cy="125750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BABB94DA-76C0-072D-600A-D90297AAE5FE}"/>
                </a:ext>
              </a:extLst>
            </p:cNvPr>
            <p:cNvSpPr/>
            <p:nvPr/>
          </p:nvSpPr>
          <p:spPr>
            <a:xfrm>
              <a:off x="5327734" y="2942461"/>
              <a:ext cx="82296" cy="123369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BBE3001D-4CE8-9AA1-DE74-A30F5DB88421}"/>
                </a:ext>
              </a:extLst>
            </p:cNvPr>
            <p:cNvSpPr/>
            <p:nvPr/>
          </p:nvSpPr>
          <p:spPr>
            <a:xfrm>
              <a:off x="5447916" y="2950268"/>
              <a:ext cx="82296" cy="122588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1847D04C-DFD9-6653-A8B4-56970366360C}"/>
                </a:ext>
              </a:extLst>
            </p:cNvPr>
            <p:cNvSpPr/>
            <p:nvPr/>
          </p:nvSpPr>
          <p:spPr>
            <a:xfrm>
              <a:off x="5570479" y="2985124"/>
              <a:ext cx="82296" cy="119103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8E732D6C-E1DD-B714-DF42-9AFE2BA98EAF}"/>
                </a:ext>
              </a:extLst>
            </p:cNvPr>
            <p:cNvSpPr/>
            <p:nvPr/>
          </p:nvSpPr>
          <p:spPr>
            <a:xfrm>
              <a:off x="5690661" y="2886869"/>
              <a:ext cx="82296" cy="128928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A7F51639-8942-3ED3-95C3-8C305D532B92}"/>
                </a:ext>
              </a:extLst>
            </p:cNvPr>
            <p:cNvSpPr/>
            <p:nvPr/>
          </p:nvSpPr>
          <p:spPr>
            <a:xfrm>
              <a:off x="5808462" y="2763043"/>
              <a:ext cx="82296" cy="141311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10A4B419-6AE2-D0CE-203A-3B7178B1AA6D}"/>
                </a:ext>
              </a:extLst>
            </p:cNvPr>
            <p:cNvSpPr/>
            <p:nvPr/>
          </p:nvSpPr>
          <p:spPr>
            <a:xfrm>
              <a:off x="5929386" y="2680324"/>
              <a:ext cx="82296" cy="149583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39518080-35ED-B7A1-7407-710C21C133F3}"/>
                </a:ext>
              </a:extLst>
            </p:cNvPr>
            <p:cNvSpPr/>
            <p:nvPr/>
          </p:nvSpPr>
          <p:spPr>
            <a:xfrm>
              <a:off x="6048678" y="2826544"/>
              <a:ext cx="82296" cy="134961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9348D757-BEAF-FA60-F7F1-FB38C9AE17D1}"/>
                </a:ext>
              </a:extLst>
            </p:cNvPr>
            <p:cNvSpPr/>
            <p:nvPr/>
          </p:nvSpPr>
          <p:spPr>
            <a:xfrm>
              <a:off x="6170351" y="2876810"/>
              <a:ext cx="82296" cy="129934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94F8A5F3-5B02-34D6-7DEF-88AE6E0B86EE}"/>
                </a:ext>
              </a:extLst>
            </p:cNvPr>
            <p:cNvSpPr/>
            <p:nvPr/>
          </p:nvSpPr>
          <p:spPr>
            <a:xfrm>
              <a:off x="6289042" y="3007520"/>
              <a:ext cx="82296" cy="11686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818A4BEC-B55F-0B20-903E-6FF957BE87E0}"/>
                </a:ext>
              </a:extLst>
            </p:cNvPr>
            <p:cNvSpPr/>
            <p:nvPr/>
          </p:nvSpPr>
          <p:spPr>
            <a:xfrm>
              <a:off x="6411262" y="2635132"/>
              <a:ext cx="82296" cy="154102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5B87D5C-FDB2-73F1-8DF9-63A1AFDE7078}"/>
                </a:ext>
              </a:extLst>
            </p:cNvPr>
            <p:cNvSpPr/>
            <p:nvPr/>
          </p:nvSpPr>
          <p:spPr>
            <a:xfrm>
              <a:off x="6532988" y="2621436"/>
              <a:ext cx="82296" cy="155471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9FDD322-7285-4E24-BA1A-37F85B065300}"/>
                </a:ext>
              </a:extLst>
            </p:cNvPr>
            <p:cNvSpPr/>
            <p:nvPr/>
          </p:nvSpPr>
          <p:spPr>
            <a:xfrm>
              <a:off x="6652931" y="2625582"/>
              <a:ext cx="82296" cy="155057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4B50FEC-1252-5D8A-261F-6360E7D0C5D9}"/>
                </a:ext>
              </a:extLst>
            </p:cNvPr>
            <p:cNvSpPr/>
            <p:nvPr/>
          </p:nvSpPr>
          <p:spPr>
            <a:xfrm>
              <a:off x="6769770" y="2925029"/>
              <a:ext cx="82296" cy="125112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1CA929E3-9191-C99C-F0B6-3CC98F077DC2}"/>
                </a:ext>
              </a:extLst>
            </p:cNvPr>
            <p:cNvSpPr/>
            <p:nvPr/>
          </p:nvSpPr>
          <p:spPr>
            <a:xfrm>
              <a:off x="6893138" y="2815063"/>
              <a:ext cx="82296" cy="136109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45380231-FC66-CAF8-93E3-CADD8690B0F2}"/>
                </a:ext>
              </a:extLst>
            </p:cNvPr>
            <p:cNvSpPr/>
            <p:nvPr/>
          </p:nvSpPr>
          <p:spPr>
            <a:xfrm>
              <a:off x="7014954" y="2819826"/>
              <a:ext cx="82296" cy="135632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38DCC58E-9461-2CBD-4DC6-0294C84988C0}"/>
                </a:ext>
              </a:extLst>
            </p:cNvPr>
            <p:cNvSpPr/>
            <p:nvPr/>
          </p:nvSpPr>
          <p:spPr>
            <a:xfrm>
              <a:off x="7133345" y="3068679"/>
              <a:ext cx="82296" cy="11074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953C5DC5-5FA4-FC26-01B9-6E718F942C49}"/>
                </a:ext>
              </a:extLst>
            </p:cNvPr>
            <p:cNvSpPr/>
            <p:nvPr/>
          </p:nvSpPr>
          <p:spPr>
            <a:xfrm>
              <a:off x="7253358" y="2801763"/>
              <a:ext cx="82296" cy="137439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190A28D1-D426-6704-76E7-461F5A309F6A}"/>
                </a:ext>
              </a:extLst>
            </p:cNvPr>
            <p:cNvSpPr/>
            <p:nvPr/>
          </p:nvSpPr>
          <p:spPr>
            <a:xfrm>
              <a:off x="7374388" y="2915861"/>
              <a:ext cx="82296" cy="126029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4C880156-1369-ACE7-687F-B29497A44BE8}"/>
                </a:ext>
              </a:extLst>
            </p:cNvPr>
            <p:cNvSpPr/>
            <p:nvPr/>
          </p:nvSpPr>
          <p:spPr>
            <a:xfrm>
              <a:off x="7496524" y="2748116"/>
              <a:ext cx="82296" cy="142803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83C7919F-86F2-BB8F-CFF7-AD4439268D4D}"/>
                </a:ext>
              </a:extLst>
            </p:cNvPr>
            <p:cNvSpPr/>
            <p:nvPr/>
          </p:nvSpPr>
          <p:spPr>
            <a:xfrm>
              <a:off x="7615245" y="2891884"/>
              <a:ext cx="82296" cy="128427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33E7381D-BBE6-B9BC-C54E-2FBA9FAA8789}"/>
                </a:ext>
              </a:extLst>
            </p:cNvPr>
            <p:cNvSpPr/>
            <p:nvPr/>
          </p:nvSpPr>
          <p:spPr>
            <a:xfrm>
              <a:off x="7736153" y="2894265"/>
              <a:ext cx="82296" cy="128188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D8C8A281-1965-73C5-7570-85118F70CA3A}"/>
                </a:ext>
              </a:extLst>
            </p:cNvPr>
            <p:cNvSpPr/>
            <p:nvPr/>
          </p:nvSpPr>
          <p:spPr>
            <a:xfrm>
              <a:off x="7854680" y="2907207"/>
              <a:ext cx="82296" cy="126894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26" name="Picture 125">
            <a:extLst>
              <a:ext uri="{FF2B5EF4-FFF2-40B4-BE49-F238E27FC236}">
                <a16:creationId xmlns:a16="http://schemas.microsoft.com/office/drawing/2014/main" id="{18545E57-B189-97EE-1014-EFCE56DC2C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846" y="867904"/>
            <a:ext cx="10090367" cy="3966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9023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-Ali, Ruslan</dc:creator>
  <cp:lastModifiedBy>MDPI</cp:lastModifiedBy>
  <cp:revision>4</cp:revision>
  <dcterms:created xsi:type="dcterms:W3CDTF">2023-07-04T12:54:03Z</dcterms:created>
  <dcterms:modified xsi:type="dcterms:W3CDTF">2023-11-22T07:52:50Z</dcterms:modified>
</cp:coreProperties>
</file>